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6162FC-EF9C-4629-B22B-9728D1F12840}" type="datetime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A1F202-6CD0-414E-B6CE-1D16FC923634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B234BC-96E8-4644-B5F7-EE395C2E7273}" type="slidenum">
              <a:rPr b="0" lang="pt-BR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6368C-3A3E-4D12-A72C-82A8B640E0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00FAF-B4F4-4C1A-92E2-78DEAF423D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E4124-AD58-4B8E-AE64-02B23EB373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568A9-332E-46BF-A316-97F92DA29E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32761-A329-4CA5-A9D0-52B0784EB8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14FF1-5786-45F8-9A6A-B24F0BC98E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CB162-FA5E-4F3E-B976-283857553A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8A99F-E31E-4E0E-BA79-F5C4BA831A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3DF24-EA06-4736-81B4-97E6C06EEB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D20DD-7DD7-4161-9D6D-1DF96A5B6A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2BAFB-C22C-4E5E-9EF5-3F84688AE5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751B8-D0B5-4DD9-857C-0BE2F4321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6C735C-51C9-413A-BCDD-B73A876A1051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DDF200-563C-48E3-9039-BBF6E42DDC66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411120" y="1091880"/>
            <a:ext cx="6589800" cy="5772600"/>
            <a:chOff x="411120" y="1091880"/>
            <a:chExt cx="6589800" cy="5772600"/>
          </a:xfrm>
        </p:grpSpPr>
        <p:sp>
          <p:nvSpPr>
            <p:cNvPr id="49" name="TextBox 3"/>
            <p:cNvSpPr/>
            <p:nvPr/>
          </p:nvSpPr>
          <p:spPr>
            <a:xfrm>
              <a:off x="792000" y="1091880"/>
              <a:ext cx="171432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 Studies from BCAC: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,113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0" name="Straight Arrow Connector 6"/>
            <p:cNvCxnSpPr>
              <a:stCxn id="49" idx="2"/>
              <a:endCxn id="51" idx="0"/>
            </p:cNvCxnSpPr>
            <p:nvPr/>
          </p:nvCxnSpPr>
          <p:spPr>
            <a:xfrm>
              <a:off x="1649160" y="1550880"/>
              <a:ext cx="5040" cy="104400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51" name="TextBox 7"/>
            <p:cNvSpPr/>
            <p:nvPr/>
          </p:nvSpPr>
          <p:spPr>
            <a:xfrm>
              <a:off x="736560" y="2594520"/>
              <a:ext cx="1834920" cy="64152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XA1 staining performed in 8,182 BCAC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7"/>
            <p:cNvSpPr/>
            <p:nvPr/>
          </p:nvSpPr>
          <p:spPr>
            <a:xfrm>
              <a:off x="1681200" y="1584000"/>
              <a:ext cx="272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61 patients without clinical dat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22"/>
            <p:cNvSpPr/>
            <p:nvPr/>
          </p:nvSpPr>
          <p:spPr>
            <a:xfrm>
              <a:off x="571320" y="3720960"/>
              <a:ext cx="216216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XA1 stain score: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,059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4" name="Straight Arrow Connector 23"/>
            <p:cNvCxnSpPr/>
            <p:nvPr/>
          </p:nvCxnSpPr>
          <p:spPr>
            <a:xfrm flipH="1">
              <a:off x="999720" y="3146400"/>
              <a:ext cx="2160" cy="57384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55" name="Straight Arrow Connector 24"/>
            <p:cNvCxnSpPr/>
            <p:nvPr/>
          </p:nvCxnSpPr>
          <p:spPr>
            <a:xfrm flipV="1">
              <a:off x="1655640" y="202644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56" name="TextBox 26"/>
            <p:cNvSpPr/>
            <p:nvPr/>
          </p:nvSpPr>
          <p:spPr>
            <a:xfrm>
              <a:off x="1666800" y="1887120"/>
              <a:ext cx="231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2 indexed with 2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nd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tum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7" name="Straight Arrow Connector 47"/>
            <p:cNvCxnSpPr/>
            <p:nvPr/>
          </p:nvCxnSpPr>
          <p:spPr>
            <a:xfrm flipV="1">
              <a:off x="1008000" y="334548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58" name="TextBox 26"/>
            <p:cNvSpPr/>
            <p:nvPr/>
          </p:nvSpPr>
          <p:spPr>
            <a:xfrm>
              <a:off x="1193760" y="3205440"/>
              <a:ext cx="21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,124 missing scor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40"/>
            <p:cNvSpPr/>
            <p:nvPr/>
          </p:nvSpPr>
          <p:spPr>
            <a:xfrm>
              <a:off x="411120" y="6343920"/>
              <a:ext cx="248436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AC ANXA1 scores: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,633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7"/>
            <p:cNvSpPr/>
            <p:nvPr/>
          </p:nvSpPr>
          <p:spPr>
            <a:xfrm>
              <a:off x="1214280" y="4708440"/>
              <a:ext cx="33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4 patients in neoadjuvant chemotherapy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8"/>
            <p:cNvSpPr/>
            <p:nvPr/>
          </p:nvSpPr>
          <p:spPr>
            <a:xfrm>
              <a:off x="1214280" y="4448160"/>
              <a:ext cx="285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8 patients with metasta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2" name="Straight Arrow Connector 31"/>
            <p:cNvCxnSpPr/>
            <p:nvPr/>
          </p:nvCxnSpPr>
          <p:spPr>
            <a:xfrm>
              <a:off x="1008360" y="5655960"/>
              <a:ext cx="1080" cy="6865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63" name="TextBox 18"/>
            <p:cNvSpPr/>
            <p:nvPr/>
          </p:nvSpPr>
          <p:spPr>
            <a:xfrm>
              <a:off x="1214280" y="5780160"/>
              <a:ext cx="542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9 patients without survival dat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4" name="Straight Arrow Connector 34"/>
            <p:cNvCxnSpPr/>
            <p:nvPr/>
          </p:nvCxnSpPr>
          <p:spPr>
            <a:xfrm flipV="1">
              <a:off x="1662120" y="174384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65" name="Straight Arrow Connector 35"/>
            <p:cNvCxnSpPr/>
            <p:nvPr/>
          </p:nvCxnSpPr>
          <p:spPr>
            <a:xfrm flipV="1">
              <a:off x="1649160" y="233748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66" name="TextBox 26"/>
            <p:cNvSpPr/>
            <p:nvPr/>
          </p:nvSpPr>
          <p:spPr>
            <a:xfrm>
              <a:off x="1876320" y="2198520"/>
              <a:ext cx="278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7,408 cases not stained for ANXA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4"/>
            <p:cNvSpPr/>
            <p:nvPr/>
          </p:nvSpPr>
          <p:spPr>
            <a:xfrm>
              <a:off x="571320" y="5104440"/>
              <a:ext cx="2214360" cy="64152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AC: 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XA1 scores for 5,752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46"/>
            <p:cNvSpPr/>
            <p:nvPr/>
          </p:nvSpPr>
          <p:spPr>
            <a:xfrm>
              <a:off x="3071880" y="5194440"/>
              <a:ext cx="216216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CA1|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mutated carriers: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ANXA1 scores for 107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9" name="Straight Arrow Connector 49"/>
            <p:cNvCxnSpPr/>
            <p:nvPr/>
          </p:nvCxnSpPr>
          <p:spPr>
            <a:xfrm>
              <a:off x="999000" y="4181400"/>
              <a:ext cx="1080" cy="1018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70" name="Straight Arrow Connector 64"/>
            <p:cNvCxnSpPr/>
            <p:nvPr/>
          </p:nvCxnSpPr>
          <p:spPr>
            <a:xfrm flipV="1">
              <a:off x="999720" y="4341240"/>
              <a:ext cx="28620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71" name="TextBox 18"/>
            <p:cNvSpPr/>
            <p:nvPr/>
          </p:nvSpPr>
          <p:spPr>
            <a:xfrm>
              <a:off x="1234800" y="4199040"/>
              <a:ext cx="169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6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 situ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umor cas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2" name="Straight Arrow Connector 72"/>
            <p:cNvCxnSpPr/>
            <p:nvPr/>
          </p:nvCxnSpPr>
          <p:spPr>
            <a:xfrm flipV="1">
              <a:off x="1000080" y="459036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73" name="Straight Arrow Connector 73"/>
            <p:cNvCxnSpPr/>
            <p:nvPr/>
          </p:nvCxnSpPr>
          <p:spPr>
            <a:xfrm flipV="1">
              <a:off x="1000080" y="485064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74" name="Straight Arrow Connector 74"/>
            <p:cNvCxnSpPr/>
            <p:nvPr/>
          </p:nvCxnSpPr>
          <p:spPr>
            <a:xfrm flipV="1">
              <a:off x="1000080" y="592704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75" name="Right Brace 75"/>
            <p:cNvSpPr/>
            <p:nvPr/>
          </p:nvSpPr>
          <p:spPr>
            <a:xfrm>
              <a:off x="5272200" y="3699000"/>
              <a:ext cx="156960" cy="556920"/>
            </a:xfrm>
            <a:custGeom>
              <a:avLst/>
              <a:gdLst>
                <a:gd name="textAreaLeft" fmla="*/ 0 w 156960"/>
                <a:gd name="textAreaRight" fmla="*/ 56520 w 156960"/>
                <a:gd name="textAreaTop" fmla="*/ 3960 h 556920"/>
                <a:gd name="textAreaBottom" fmla="*/ 552960 h 556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54"/>
                    <a:pt x="10800" y="508"/>
                  </a:cubicBezTo>
                  <a:lnTo>
                    <a:pt x="10800" y="10292"/>
                  </a:lnTo>
                  <a:cubicBezTo>
                    <a:pt x="10800" y="10546"/>
                    <a:pt x="16200" y="10800"/>
                    <a:pt x="21600" y="10800"/>
                  </a:cubicBezTo>
                  <a:cubicBezTo>
                    <a:pt x="16200" y="10800"/>
                    <a:pt x="10800" y="11054"/>
                    <a:pt x="10800" y="11308"/>
                  </a:cubicBezTo>
                  <a:lnTo>
                    <a:pt x="10800" y="21092"/>
                  </a:lnTo>
                  <a:cubicBezTo>
                    <a:pt x="10800" y="21346"/>
                    <a:pt x="5400" y="21600"/>
                    <a:pt x="0" y="21600"/>
                  </a:cubicBezTo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76"/>
            <p:cNvSpPr/>
            <p:nvPr/>
          </p:nvSpPr>
          <p:spPr>
            <a:xfrm>
              <a:off x="5467320" y="3738240"/>
              <a:ext cx="92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escriptive ana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78"/>
            <p:cNvSpPr/>
            <p:nvPr/>
          </p:nvSpPr>
          <p:spPr>
            <a:xfrm>
              <a:off x="5500800" y="5197320"/>
              <a:ext cx="92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sociation ana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80"/>
            <p:cNvSpPr/>
            <p:nvPr/>
          </p:nvSpPr>
          <p:spPr>
            <a:xfrm>
              <a:off x="3120840" y="6359760"/>
              <a:ext cx="92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rvival ana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42"/>
            <p:cNvSpPr/>
            <p:nvPr/>
          </p:nvSpPr>
          <p:spPr>
            <a:xfrm>
              <a:off x="3071880" y="3738240"/>
              <a:ext cx="216216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CA1|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mutated carriers:</a:t>
              </a:r>
              <a:br>
                <a:rPr sz="1200"/>
              </a:b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118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45"/>
            <p:cNvSpPr/>
            <p:nvPr/>
          </p:nvSpPr>
          <p:spPr>
            <a:xfrm>
              <a:off x="3071880" y="2700000"/>
              <a:ext cx="2162160" cy="45900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XA1 staining performed in 132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CA1|2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mutated patien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26"/>
            <p:cNvSpPr/>
            <p:nvPr/>
          </p:nvSpPr>
          <p:spPr>
            <a:xfrm>
              <a:off x="2636640" y="2757600"/>
              <a:ext cx="377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8"/>
            <p:cNvSpPr/>
            <p:nvPr/>
          </p:nvSpPr>
          <p:spPr>
            <a:xfrm>
              <a:off x="4143240" y="4462560"/>
              <a:ext cx="285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 patients with metasta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3" name="Straight Arrow Connector 57"/>
            <p:cNvCxnSpPr/>
            <p:nvPr/>
          </p:nvCxnSpPr>
          <p:spPr>
            <a:xfrm>
              <a:off x="3927960" y="4189320"/>
              <a:ext cx="1080" cy="1018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84" name="Straight Arrow Connector 58"/>
            <p:cNvCxnSpPr/>
            <p:nvPr/>
          </p:nvCxnSpPr>
          <p:spPr>
            <a:xfrm flipV="1">
              <a:off x="3928680" y="4349160"/>
              <a:ext cx="28620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85" name="TextBox 18"/>
            <p:cNvSpPr/>
            <p:nvPr/>
          </p:nvSpPr>
          <p:spPr>
            <a:xfrm>
              <a:off x="4164120" y="4206960"/>
              <a:ext cx="169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 situ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umor cas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6" name="Straight Arrow Connector 62"/>
            <p:cNvCxnSpPr/>
            <p:nvPr/>
          </p:nvCxnSpPr>
          <p:spPr>
            <a:xfrm flipV="1">
              <a:off x="3929040" y="459828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87" name="Right Brace 63"/>
            <p:cNvSpPr/>
            <p:nvPr/>
          </p:nvSpPr>
          <p:spPr>
            <a:xfrm>
              <a:off x="5286600" y="5141880"/>
              <a:ext cx="156960" cy="556920"/>
            </a:xfrm>
            <a:custGeom>
              <a:avLst/>
              <a:gdLst>
                <a:gd name="textAreaLeft" fmla="*/ 0 w 156960"/>
                <a:gd name="textAreaRight" fmla="*/ 56520 w 156960"/>
                <a:gd name="textAreaTop" fmla="*/ 3960 h 556920"/>
                <a:gd name="textAreaBottom" fmla="*/ 552960 h 556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54"/>
                    <a:pt x="10800" y="508"/>
                  </a:cubicBezTo>
                  <a:lnTo>
                    <a:pt x="10800" y="10292"/>
                  </a:lnTo>
                  <a:cubicBezTo>
                    <a:pt x="10800" y="10546"/>
                    <a:pt x="16200" y="10800"/>
                    <a:pt x="21600" y="10800"/>
                  </a:cubicBezTo>
                  <a:cubicBezTo>
                    <a:pt x="16200" y="10800"/>
                    <a:pt x="10800" y="11054"/>
                    <a:pt x="10800" y="11308"/>
                  </a:cubicBezTo>
                  <a:lnTo>
                    <a:pt x="10800" y="21092"/>
                  </a:lnTo>
                  <a:cubicBezTo>
                    <a:pt x="10800" y="21346"/>
                    <a:pt x="5400" y="21600"/>
                    <a:pt x="0" y="21600"/>
                  </a:cubicBezTo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ight Brace 65"/>
            <p:cNvSpPr/>
            <p:nvPr/>
          </p:nvSpPr>
          <p:spPr>
            <a:xfrm>
              <a:off x="2928960" y="6307560"/>
              <a:ext cx="156960" cy="556920"/>
            </a:xfrm>
            <a:custGeom>
              <a:avLst/>
              <a:gdLst>
                <a:gd name="textAreaLeft" fmla="*/ 0 w 156960"/>
                <a:gd name="textAreaRight" fmla="*/ 56520 w 156960"/>
                <a:gd name="textAreaTop" fmla="*/ 3960 h 556920"/>
                <a:gd name="textAreaBottom" fmla="*/ 552960 h 556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54"/>
                    <a:pt x="10800" y="508"/>
                  </a:cubicBezTo>
                  <a:lnTo>
                    <a:pt x="10800" y="10292"/>
                  </a:lnTo>
                  <a:cubicBezTo>
                    <a:pt x="10800" y="10546"/>
                    <a:pt x="16200" y="10800"/>
                    <a:pt x="21600" y="10800"/>
                  </a:cubicBezTo>
                  <a:cubicBezTo>
                    <a:pt x="16200" y="10800"/>
                    <a:pt x="10800" y="11054"/>
                    <a:pt x="10800" y="11308"/>
                  </a:cubicBezTo>
                  <a:lnTo>
                    <a:pt x="10800" y="21092"/>
                  </a:lnTo>
                  <a:cubicBezTo>
                    <a:pt x="10800" y="21346"/>
                    <a:pt x="5400" y="21600"/>
                    <a:pt x="0" y="21600"/>
                  </a:cubicBezTo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9" name="Straight Arrow Connector 67"/>
            <p:cNvCxnSpPr/>
            <p:nvPr/>
          </p:nvCxnSpPr>
          <p:spPr>
            <a:xfrm flipH="1">
              <a:off x="3928680" y="3153960"/>
              <a:ext cx="2160" cy="6166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cxnSp>
          <p:nvCxnSpPr>
            <p:cNvPr id="90" name="Straight Arrow Connector 70"/>
            <p:cNvCxnSpPr/>
            <p:nvPr/>
          </p:nvCxnSpPr>
          <p:spPr>
            <a:xfrm flipV="1">
              <a:off x="3936960" y="3339360"/>
              <a:ext cx="26712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lg" type="arrow" w="lg"/>
            </a:ln>
          </p:spPr>
        </p:cxnSp>
        <p:sp>
          <p:nvSpPr>
            <p:cNvPr id="91" name="TextBox 26"/>
            <p:cNvSpPr/>
            <p:nvPr/>
          </p:nvSpPr>
          <p:spPr>
            <a:xfrm>
              <a:off x="4122720" y="3198960"/>
              <a:ext cx="21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 missing scor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TextBox 19"/>
          <p:cNvSpPr/>
          <p:nvPr/>
        </p:nvSpPr>
        <p:spPr>
          <a:xfrm>
            <a:off x="333360" y="6973920"/>
            <a:ext cx="60483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ow-chart showing the criteria used for the selection of patients in each analysi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7:51Z</dcterms:modified>
  <cp:revision>413</cp:revision>
  <dc:subject/>
  <dc:title>Slide 1</dc:title>
</cp:coreProperties>
</file>